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6197"/>
  </p:normalViewPr>
  <p:slideViewPr>
    <p:cSldViewPr snapToGrid="0" snapToObjects="1">
      <p:cViewPr>
        <p:scale>
          <a:sx n="100" d="100"/>
          <a:sy n="100" d="100"/>
        </p:scale>
        <p:origin x="-736" y="5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57B3DC-D97A-C84B-8B79-BD984385137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1501425-E65C-554C-A130-340B50CC83B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2DA28D-6D99-AC43-AD55-73737E0AB7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730E8F-501C-2245-8809-1FA4CF461EB7}" type="datetimeFigureOut">
              <a:rPr lang="en-US" smtClean="0"/>
              <a:t>11/1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1103C2-D868-2845-906E-088FE6A1ED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CB829E-5403-2F4C-A236-FFF178DC44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10C98-28FA-6943-BFA1-67DBD750AE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15329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992F2A-9C4B-D341-866F-F2888C3D00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5B49660-DDED-2A4B-9BC8-7BA598DACF4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0D5403-503F-A242-91D9-9ED3380FA5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730E8F-501C-2245-8809-1FA4CF461EB7}" type="datetimeFigureOut">
              <a:rPr lang="en-US" smtClean="0"/>
              <a:t>11/1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32E308-3CFF-9440-8736-B547172A1B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A76AEF-E780-604A-B572-0C5EEB9F96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10C98-28FA-6943-BFA1-67DBD750AE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87513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FFFFA2A-DF4A-3E48-9668-2B751A34324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47E58F0-F1E4-4842-A7EB-DDE7D402A47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E6051D-3597-B14D-B211-D9FABA6623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730E8F-501C-2245-8809-1FA4CF461EB7}" type="datetimeFigureOut">
              <a:rPr lang="en-US" smtClean="0"/>
              <a:t>11/1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BB2E00-8738-BC43-93B0-EA2293D78E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25AF9D-B85B-3D42-9C9B-892944FC53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10C98-28FA-6943-BFA1-67DBD750AE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72463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2601C6-49D7-7041-9C1F-7852C9A82B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02A1FB-8261-E146-B300-BE212EB9150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8EAFCF-FB8E-5E44-8C45-527EE8EB97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730E8F-501C-2245-8809-1FA4CF461EB7}" type="datetimeFigureOut">
              <a:rPr lang="en-US" smtClean="0"/>
              <a:t>11/1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1B1A57-163C-EE43-A541-73A7357485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150697-6829-BA40-BC32-365B665E8F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10C98-28FA-6943-BFA1-67DBD750AE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62576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ACEEA3-29AE-F540-9753-92CD078129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CA7D332-B955-B841-B231-9444BCDC93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223EFC-4404-934F-993B-A917C97BC0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730E8F-501C-2245-8809-1FA4CF461EB7}" type="datetimeFigureOut">
              <a:rPr lang="en-US" smtClean="0"/>
              <a:t>11/1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421668-3B16-1641-BF3C-9F2EF25394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CD8170-C5A3-F94D-A113-59B53EFEE6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10C98-28FA-6943-BFA1-67DBD750AE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02076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5ECE97-11F1-134B-8C65-7FCE6743BC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286699E-0814-D74C-80FB-BCEDBA086F9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6C32E88-6079-1345-B30B-51F7C792E40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3A72D66-D544-554A-A577-198B0B6B7C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730E8F-501C-2245-8809-1FA4CF461EB7}" type="datetimeFigureOut">
              <a:rPr lang="en-US" smtClean="0"/>
              <a:t>11/1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44D11E2-E0CD-4343-8968-520A7A61A0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4F0E6F7-06F3-C444-9A9F-2EA1885C51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10C98-28FA-6943-BFA1-67DBD750AE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92924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6B4B9B-E38C-B54C-8FAD-1F85FEF414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C081845-4A01-1347-A82B-2006696028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C24CD9E-D303-A44C-8163-AB7EAB0D71E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1304038-1C9C-EA47-9F08-B9A17A10AD5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3937918-6FF8-1040-AE8A-5D1E6F68AFE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B724CFB-43AF-2141-AD1D-13D65D888C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730E8F-501C-2245-8809-1FA4CF461EB7}" type="datetimeFigureOut">
              <a:rPr lang="en-US" smtClean="0"/>
              <a:t>11/17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D425A7D-547F-944C-AA97-88DFF2B637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A2A20C6-4A72-CC49-897B-7F68CBAA04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10C98-28FA-6943-BFA1-67DBD750AE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7368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A13760-D0E8-4E49-9337-0682CEF2F6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4F187B8-C414-5E4F-8C74-C1ACB65A19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730E8F-501C-2245-8809-1FA4CF461EB7}" type="datetimeFigureOut">
              <a:rPr lang="en-US" smtClean="0"/>
              <a:t>11/17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52999C6-85EE-DE47-8084-166B7AD588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FBC206F-4A4E-3848-9FF7-A069E03F7A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10C98-28FA-6943-BFA1-67DBD750AE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73892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1518679-FA25-0041-B5F8-7063DBAA55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730E8F-501C-2245-8809-1FA4CF461EB7}" type="datetimeFigureOut">
              <a:rPr lang="en-US" smtClean="0"/>
              <a:t>11/17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2616E1B-C5C9-344A-8EBC-159BA88AE3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A2B47FA-26DE-794C-9B9A-9CCC4C301F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10C98-28FA-6943-BFA1-67DBD750AE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20442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667F54-7829-4A4B-A9BC-6A16BCBA1F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17C4780-468B-4D41-9BFE-0929F76DE5F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AAD3074-01E1-F340-9C75-C6645648DAB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44B370B-1B8E-C844-B3C8-2D4FA23566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730E8F-501C-2245-8809-1FA4CF461EB7}" type="datetimeFigureOut">
              <a:rPr lang="en-US" smtClean="0"/>
              <a:t>11/1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D407C6-526A-D149-BE77-431463174F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6BAE100-8C7C-2C43-821E-6566F8A66F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10C98-28FA-6943-BFA1-67DBD750AE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55168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C6BC34-7DD4-4A4A-88B8-A7872C22F1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853B8DD-7AD0-D444-AF94-52AAA5C3F1B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BE1F5C7-27B3-934D-AAE2-C60568434D6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D0A0017-274A-154F-AA84-7779018D96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730E8F-501C-2245-8809-1FA4CF461EB7}" type="datetimeFigureOut">
              <a:rPr lang="en-US" smtClean="0"/>
              <a:t>11/1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7807E52-2187-D14D-9381-EC6DC215D7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1CFC024-C126-414B-B286-9FF0DC7DDD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10C98-28FA-6943-BFA1-67DBD750AE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86602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E693EEF-B999-F544-B1C9-741F73D54C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DAE7CF5-951C-7E4F-A44C-7416A7274A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4A47EB-36F6-EC49-971F-300AE5A5963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730E8F-501C-2245-8809-1FA4CF461EB7}" type="datetimeFigureOut">
              <a:rPr lang="en-US" smtClean="0"/>
              <a:t>11/1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BD04A9-7CBB-684A-B9BB-747FA87D30A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E69E0B-DC0F-6A41-B027-E3B250E796B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510C98-28FA-6943-BFA1-67DBD750AE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8800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25FB599F-48ED-174C-B658-2BB2808826EA}"/>
              </a:ext>
            </a:extLst>
          </p:cNvPr>
          <p:cNvGrpSpPr/>
          <p:nvPr/>
        </p:nvGrpSpPr>
        <p:grpSpPr>
          <a:xfrm>
            <a:off x="4773938" y="-75210"/>
            <a:ext cx="2644124" cy="3910205"/>
            <a:chOff x="3932178" y="105309"/>
            <a:chExt cx="2644124" cy="3910205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5636CACD-43DB-0B4C-9A7F-C578B451DAD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-1" r="24441" b="434"/>
            <a:stretch/>
          </p:blipFill>
          <p:spPr>
            <a:xfrm>
              <a:off x="4508948" y="2321165"/>
              <a:ext cx="1485452" cy="546261"/>
            </a:xfrm>
            <a:prstGeom prst="rect">
              <a:avLst/>
            </a:prstGeom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E665A1AB-3531-FC44-A9C7-27C61C12DC3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r="24442" b="-2732"/>
            <a:stretch/>
          </p:blipFill>
          <p:spPr>
            <a:xfrm>
              <a:off x="4508948" y="2882737"/>
              <a:ext cx="1485452" cy="563628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64B625C8-9C49-8D43-ABE7-9BD78F67753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r="24442" b="-2732"/>
            <a:stretch/>
          </p:blipFill>
          <p:spPr>
            <a:xfrm>
              <a:off x="4508948" y="3451886"/>
              <a:ext cx="1485452" cy="563628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785487C-E59B-0B46-8408-8570A2BFD912}"/>
                </a:ext>
              </a:extLst>
            </p:cNvPr>
            <p:cNvSpPr txBox="1"/>
            <p:nvPr/>
          </p:nvSpPr>
          <p:spPr>
            <a:xfrm rot="18660000">
              <a:off x="4567615" y="1930714"/>
              <a:ext cx="4251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T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2A601631-1DCD-9B45-9C8F-B8AF032A8E58}"/>
                </a:ext>
              </a:extLst>
            </p:cNvPr>
            <p:cNvSpPr txBox="1"/>
            <p:nvPr/>
          </p:nvSpPr>
          <p:spPr>
            <a:xfrm rot="18665688">
              <a:off x="5057425" y="1791627"/>
              <a:ext cx="8321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cdc22-1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2BA813D6-AE09-384E-A8B8-FE4DC1A5EB42}"/>
                </a:ext>
              </a:extLst>
            </p:cNvPr>
            <p:cNvSpPr txBox="1"/>
            <p:nvPr/>
          </p:nvSpPr>
          <p:spPr>
            <a:xfrm rot="18660000">
              <a:off x="5208366" y="1196246"/>
              <a:ext cx="24588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CDC22:CCDC22-RFP(</a:t>
              </a:r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cdc22-1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3D39E029-FDC6-9A42-AD45-F78E72D29597}"/>
                </a:ext>
              </a:extLst>
            </p:cNvPr>
            <p:cNvSpPr txBox="1"/>
            <p:nvPr/>
          </p:nvSpPr>
          <p:spPr>
            <a:xfrm>
              <a:off x="4287225" y="2439540"/>
              <a:ext cx="3814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6A22B3A0-4F0C-5B43-A964-0EBFBF5DEB4C}"/>
                </a:ext>
              </a:extLst>
            </p:cNvPr>
            <p:cNvSpPr txBox="1"/>
            <p:nvPr/>
          </p:nvSpPr>
          <p:spPr>
            <a:xfrm>
              <a:off x="4293048" y="3003672"/>
              <a:ext cx="3814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4E1AD240-FE8D-BE4F-BE86-4C8759AD92EC}"/>
                </a:ext>
              </a:extLst>
            </p:cNvPr>
            <p:cNvSpPr txBox="1"/>
            <p:nvPr/>
          </p:nvSpPr>
          <p:spPr>
            <a:xfrm>
              <a:off x="4318224" y="3630843"/>
              <a:ext cx="3814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D04EA32D-627F-5042-B8E0-0FDADDC2E87D}"/>
                </a:ext>
              </a:extLst>
            </p:cNvPr>
            <p:cNvSpPr txBox="1"/>
            <p:nvPr/>
          </p:nvSpPr>
          <p:spPr>
            <a:xfrm rot="16200000">
              <a:off x="3177219" y="2862727"/>
              <a:ext cx="181769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imer Combination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EB951327-DB18-7F41-8F17-E1105820FBD7}"/>
                </a:ext>
              </a:extLst>
            </p:cNvPr>
            <p:cNvSpPr txBox="1"/>
            <p:nvPr/>
          </p:nvSpPr>
          <p:spPr>
            <a:xfrm>
              <a:off x="4699672" y="1372197"/>
              <a:ext cx="117168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enotype</a:t>
              </a:r>
            </a:p>
          </p:txBody>
        </p:sp>
      </p:grpSp>
      <p:grpSp>
        <p:nvGrpSpPr>
          <p:cNvPr id="64" name="Group 63">
            <a:extLst>
              <a:ext uri="{FF2B5EF4-FFF2-40B4-BE49-F238E27FC236}">
                <a16:creationId xmlns:a16="http://schemas.microsoft.com/office/drawing/2014/main" id="{1BA54F92-B1DA-EC41-9806-678772DA1D37}"/>
              </a:ext>
            </a:extLst>
          </p:cNvPr>
          <p:cNvGrpSpPr/>
          <p:nvPr/>
        </p:nvGrpSpPr>
        <p:grpSpPr>
          <a:xfrm>
            <a:off x="3010807" y="4032078"/>
            <a:ext cx="6232936" cy="1393603"/>
            <a:chOff x="3233316" y="4149693"/>
            <a:chExt cx="6232936" cy="1393603"/>
          </a:xfrm>
        </p:grpSpPr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2E9A4864-6445-AA43-B996-DE0B357ECD04}"/>
                </a:ext>
              </a:extLst>
            </p:cNvPr>
            <p:cNvSpPr>
              <a:spLocks/>
            </p:cNvSpPr>
            <p:nvPr/>
          </p:nvSpPr>
          <p:spPr>
            <a:xfrm>
              <a:off x="5599950" y="4538563"/>
              <a:ext cx="282303" cy="112025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3C8FE5EB-F7CD-324A-8477-B880BD8827C7}"/>
                </a:ext>
              </a:extLst>
            </p:cNvPr>
            <p:cNvSpPr>
              <a:spLocks/>
            </p:cNvSpPr>
            <p:nvPr/>
          </p:nvSpPr>
          <p:spPr>
            <a:xfrm>
              <a:off x="6171604" y="4538562"/>
              <a:ext cx="429101" cy="112025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A42C0286-AB0A-9443-B2E8-ADCBCE36A572}"/>
                </a:ext>
              </a:extLst>
            </p:cNvPr>
            <p:cNvSpPr>
              <a:spLocks/>
            </p:cNvSpPr>
            <p:nvPr/>
          </p:nvSpPr>
          <p:spPr>
            <a:xfrm>
              <a:off x="6769093" y="4537936"/>
              <a:ext cx="242781" cy="112025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6F434F3E-3A98-E240-8FAC-09FA4B0B9860}"/>
                </a:ext>
              </a:extLst>
            </p:cNvPr>
            <p:cNvSpPr>
              <a:spLocks/>
            </p:cNvSpPr>
            <p:nvPr/>
          </p:nvSpPr>
          <p:spPr>
            <a:xfrm>
              <a:off x="7152590" y="4538562"/>
              <a:ext cx="158090" cy="112025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DBDDB985-4FBD-664C-B635-9C160C023F4B}"/>
                </a:ext>
              </a:extLst>
            </p:cNvPr>
            <p:cNvSpPr>
              <a:spLocks/>
            </p:cNvSpPr>
            <p:nvPr/>
          </p:nvSpPr>
          <p:spPr>
            <a:xfrm>
              <a:off x="7445592" y="4538562"/>
              <a:ext cx="242781" cy="112025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60F7B97D-CE87-E848-9AF0-CA9222EF54C0}"/>
                </a:ext>
              </a:extLst>
            </p:cNvPr>
            <p:cNvSpPr>
              <a:spLocks/>
            </p:cNvSpPr>
            <p:nvPr/>
          </p:nvSpPr>
          <p:spPr>
            <a:xfrm>
              <a:off x="7840817" y="4538562"/>
              <a:ext cx="248427" cy="112025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28" name="Straight Connector 27">
              <a:extLst>
                <a:ext uri="{FF2B5EF4-FFF2-40B4-BE49-F238E27FC236}">
                  <a16:creationId xmlns:a16="http://schemas.microsoft.com/office/drawing/2014/main" id="{C5B1F051-AC87-BA4C-A8A8-9077C90640E2}"/>
                </a:ext>
              </a:extLst>
            </p:cNvPr>
            <p:cNvCxnSpPr>
              <a:cxnSpLocks/>
            </p:cNvCxnSpPr>
            <p:nvPr/>
          </p:nvCxnSpPr>
          <p:spPr>
            <a:xfrm>
              <a:off x="5882253" y="4594575"/>
              <a:ext cx="28512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9D32207C-69EB-BA4E-994D-1526A1C67238}"/>
                </a:ext>
              </a:extLst>
            </p:cNvPr>
            <p:cNvCxnSpPr>
              <a:cxnSpLocks/>
            </p:cNvCxnSpPr>
            <p:nvPr/>
          </p:nvCxnSpPr>
          <p:spPr>
            <a:xfrm>
              <a:off x="6600705" y="4594575"/>
              <a:ext cx="16655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>
              <a:extLst>
                <a:ext uri="{FF2B5EF4-FFF2-40B4-BE49-F238E27FC236}">
                  <a16:creationId xmlns:a16="http://schemas.microsoft.com/office/drawing/2014/main" id="{D4496144-7CAC-3848-B615-07EF0C2C72D6}"/>
                </a:ext>
              </a:extLst>
            </p:cNvPr>
            <p:cNvCxnSpPr>
              <a:cxnSpLocks/>
            </p:cNvCxnSpPr>
            <p:nvPr/>
          </p:nvCxnSpPr>
          <p:spPr>
            <a:xfrm>
              <a:off x="7011874" y="4595388"/>
              <a:ext cx="13550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5A3DEE4D-7FC1-CA49-9CBB-7439C7AF7748}"/>
                </a:ext>
              </a:extLst>
            </p:cNvPr>
            <p:cNvCxnSpPr>
              <a:cxnSpLocks/>
            </p:cNvCxnSpPr>
            <p:nvPr/>
          </p:nvCxnSpPr>
          <p:spPr>
            <a:xfrm>
              <a:off x="7310679" y="4594575"/>
              <a:ext cx="12986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7354F25C-35D5-C145-A8BF-1F9A1940C430}"/>
                </a:ext>
              </a:extLst>
            </p:cNvPr>
            <p:cNvCxnSpPr>
              <a:cxnSpLocks/>
            </p:cNvCxnSpPr>
            <p:nvPr/>
          </p:nvCxnSpPr>
          <p:spPr>
            <a:xfrm>
              <a:off x="7688373" y="4595388"/>
              <a:ext cx="15244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Triangle 32">
              <a:extLst>
                <a:ext uri="{FF2B5EF4-FFF2-40B4-BE49-F238E27FC236}">
                  <a16:creationId xmlns:a16="http://schemas.microsoft.com/office/drawing/2014/main" id="{88C90D83-454A-1643-BB77-17D9DCD7A225}"/>
                </a:ext>
              </a:extLst>
            </p:cNvPr>
            <p:cNvSpPr>
              <a:spLocks/>
            </p:cNvSpPr>
            <p:nvPr/>
          </p:nvSpPr>
          <p:spPr>
            <a:xfrm rot="10800000">
              <a:off x="6805527" y="4447414"/>
              <a:ext cx="217069" cy="91045"/>
            </a:xfrm>
            <a:prstGeom prst="triangle">
              <a:avLst/>
            </a:prstGeom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F20C5895-B4D8-EF4D-896A-9A8DB7EFA945}"/>
                </a:ext>
              </a:extLst>
            </p:cNvPr>
            <p:cNvCxnSpPr/>
            <p:nvPr/>
          </p:nvCxnSpPr>
          <p:spPr>
            <a:xfrm>
              <a:off x="8223175" y="5417624"/>
              <a:ext cx="30003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3EE36359-C2AB-434D-9988-B98FA85A83C6}"/>
                </a:ext>
              </a:extLst>
            </p:cNvPr>
            <p:cNvSpPr txBox="1"/>
            <p:nvPr/>
          </p:nvSpPr>
          <p:spPr>
            <a:xfrm>
              <a:off x="8479444" y="5281686"/>
              <a:ext cx="54854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250bp</a:t>
              </a:r>
            </a:p>
          </p:txBody>
        </p:sp>
        <p:cxnSp>
          <p:nvCxnSpPr>
            <p:cNvPr id="11" name="Straight Arrow Connector 10">
              <a:extLst>
                <a:ext uri="{FF2B5EF4-FFF2-40B4-BE49-F238E27FC236}">
                  <a16:creationId xmlns:a16="http://schemas.microsoft.com/office/drawing/2014/main" id="{5998B107-8398-414C-9ED1-C031D6B05FAA}"/>
                </a:ext>
              </a:extLst>
            </p:cNvPr>
            <p:cNvCxnSpPr>
              <a:cxnSpLocks/>
            </p:cNvCxnSpPr>
            <p:nvPr/>
          </p:nvCxnSpPr>
          <p:spPr>
            <a:xfrm>
              <a:off x="5636804" y="4477278"/>
              <a:ext cx="2743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Arrow Connector 37">
              <a:extLst>
                <a:ext uri="{FF2B5EF4-FFF2-40B4-BE49-F238E27FC236}">
                  <a16:creationId xmlns:a16="http://schemas.microsoft.com/office/drawing/2014/main" id="{C6CFD653-E1C4-934A-9785-882E39D6DB5A}"/>
                </a:ext>
              </a:extLst>
            </p:cNvPr>
            <p:cNvCxnSpPr/>
            <p:nvPr/>
          </p:nvCxnSpPr>
          <p:spPr>
            <a:xfrm flipH="1">
              <a:off x="6805526" y="4386136"/>
              <a:ext cx="2743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Arrow Connector 38">
              <a:extLst>
                <a:ext uri="{FF2B5EF4-FFF2-40B4-BE49-F238E27FC236}">
                  <a16:creationId xmlns:a16="http://schemas.microsoft.com/office/drawing/2014/main" id="{313D5E41-7187-4642-8B76-F47986498F96}"/>
                </a:ext>
              </a:extLst>
            </p:cNvPr>
            <p:cNvCxnSpPr/>
            <p:nvPr/>
          </p:nvCxnSpPr>
          <p:spPr>
            <a:xfrm flipH="1">
              <a:off x="8012174" y="4473988"/>
              <a:ext cx="2743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F642A0D3-9B70-E545-89AF-CE46BB98E8FD}"/>
                </a:ext>
              </a:extLst>
            </p:cNvPr>
            <p:cNvSpPr>
              <a:spLocks/>
            </p:cNvSpPr>
            <p:nvPr/>
          </p:nvSpPr>
          <p:spPr>
            <a:xfrm>
              <a:off x="8084957" y="4537310"/>
              <a:ext cx="813816" cy="112025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42" name="Straight Arrow Connector 41">
              <a:extLst>
                <a:ext uri="{FF2B5EF4-FFF2-40B4-BE49-F238E27FC236}">
                  <a16:creationId xmlns:a16="http://schemas.microsoft.com/office/drawing/2014/main" id="{64C1E6D4-8469-2549-BCCE-F77BB957376C}"/>
                </a:ext>
              </a:extLst>
            </p:cNvPr>
            <p:cNvCxnSpPr/>
            <p:nvPr/>
          </p:nvCxnSpPr>
          <p:spPr>
            <a:xfrm flipH="1">
              <a:off x="8701602" y="4477278"/>
              <a:ext cx="2743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>
              <a:extLst>
                <a:ext uri="{FF2B5EF4-FFF2-40B4-BE49-F238E27FC236}">
                  <a16:creationId xmlns:a16="http://schemas.microsoft.com/office/drawing/2014/main" id="{E2590693-A49C-4148-BF22-4A20100CDEE1}"/>
                </a:ext>
              </a:extLst>
            </p:cNvPr>
            <p:cNvCxnSpPr/>
            <p:nvPr/>
          </p:nvCxnSpPr>
          <p:spPr>
            <a:xfrm>
              <a:off x="3317273" y="4593322"/>
              <a:ext cx="227685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Arrow Connector 45">
              <a:extLst>
                <a:ext uri="{FF2B5EF4-FFF2-40B4-BE49-F238E27FC236}">
                  <a16:creationId xmlns:a16="http://schemas.microsoft.com/office/drawing/2014/main" id="{3CE6CF75-E055-DE4C-945B-FE316D774823}"/>
                </a:ext>
              </a:extLst>
            </p:cNvPr>
            <p:cNvCxnSpPr>
              <a:cxnSpLocks/>
            </p:cNvCxnSpPr>
            <p:nvPr/>
          </p:nvCxnSpPr>
          <p:spPr>
            <a:xfrm>
              <a:off x="3372995" y="4454054"/>
              <a:ext cx="2743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Left Brace 46">
              <a:extLst>
                <a:ext uri="{FF2B5EF4-FFF2-40B4-BE49-F238E27FC236}">
                  <a16:creationId xmlns:a16="http://schemas.microsoft.com/office/drawing/2014/main" id="{4430A631-385F-3743-B1C6-2810DA88642F}"/>
                </a:ext>
              </a:extLst>
            </p:cNvPr>
            <p:cNvSpPr/>
            <p:nvPr/>
          </p:nvSpPr>
          <p:spPr>
            <a:xfrm rot="16200000">
              <a:off x="4385699" y="3665651"/>
              <a:ext cx="155448" cy="2276856"/>
            </a:xfrm>
            <a:prstGeom prst="leftBrac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2010CFAC-0527-A240-BE95-2E077EB317EB}"/>
                </a:ext>
              </a:extLst>
            </p:cNvPr>
            <p:cNvSpPr txBox="1"/>
            <p:nvPr/>
          </p:nvSpPr>
          <p:spPr>
            <a:xfrm>
              <a:off x="3870055" y="4925127"/>
              <a:ext cx="13090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i="1" dirty="0"/>
                <a:t>CCDC22 </a:t>
              </a:r>
              <a:r>
                <a:rPr lang="en-US" sz="1200" dirty="0"/>
                <a:t>Promoter</a:t>
              </a:r>
              <a:endParaRPr lang="en-US" sz="1200" i="1" dirty="0"/>
            </a:p>
          </p:txBody>
        </p:sp>
        <p:sp>
          <p:nvSpPr>
            <p:cNvPr id="49" name="Left Brace 48">
              <a:extLst>
                <a:ext uri="{FF2B5EF4-FFF2-40B4-BE49-F238E27FC236}">
                  <a16:creationId xmlns:a16="http://schemas.microsoft.com/office/drawing/2014/main" id="{593B79A6-DDED-9B46-869F-706D393204D6}"/>
                </a:ext>
              </a:extLst>
            </p:cNvPr>
            <p:cNvSpPr/>
            <p:nvPr/>
          </p:nvSpPr>
          <p:spPr>
            <a:xfrm rot="16200000">
              <a:off x="6760109" y="3573016"/>
              <a:ext cx="172129" cy="2477566"/>
            </a:xfrm>
            <a:prstGeom prst="leftBrac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F2CA58E0-45D4-B444-8B0B-09C835F844FC}"/>
                </a:ext>
              </a:extLst>
            </p:cNvPr>
            <p:cNvSpPr txBox="1"/>
            <p:nvPr/>
          </p:nvSpPr>
          <p:spPr>
            <a:xfrm>
              <a:off x="5952116" y="4928788"/>
              <a:ext cx="191590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i="1" dirty="0"/>
                <a:t>CCDC22 </a:t>
              </a:r>
              <a:r>
                <a:rPr lang="en-US" sz="1200" dirty="0"/>
                <a:t>Genomic Sequence</a:t>
              </a:r>
              <a:endParaRPr lang="en-US" sz="1200" i="1" dirty="0"/>
            </a:p>
          </p:txBody>
        </p:sp>
        <p:sp>
          <p:nvSpPr>
            <p:cNvPr id="51" name="Left Brace 50">
              <a:extLst>
                <a:ext uri="{FF2B5EF4-FFF2-40B4-BE49-F238E27FC236}">
                  <a16:creationId xmlns:a16="http://schemas.microsoft.com/office/drawing/2014/main" id="{5BB2E024-E85A-BE44-9F03-09BE25DFB269}"/>
                </a:ext>
              </a:extLst>
            </p:cNvPr>
            <p:cNvSpPr/>
            <p:nvPr/>
          </p:nvSpPr>
          <p:spPr>
            <a:xfrm rot="16200000">
              <a:off x="8404998" y="4404890"/>
              <a:ext cx="173736" cy="813817"/>
            </a:xfrm>
            <a:prstGeom prst="leftBrac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0E389D39-EFA6-DE48-B98D-9DE607C4B388}"/>
                </a:ext>
              </a:extLst>
            </p:cNvPr>
            <p:cNvSpPr txBox="1"/>
            <p:nvPr/>
          </p:nvSpPr>
          <p:spPr>
            <a:xfrm>
              <a:off x="7938270" y="4925127"/>
              <a:ext cx="1527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RFP Coding Sequence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F2F66DC5-8C39-7344-B860-F3D6A13BCED0}"/>
                </a:ext>
              </a:extLst>
            </p:cNvPr>
            <p:cNvSpPr txBox="1"/>
            <p:nvPr/>
          </p:nvSpPr>
          <p:spPr>
            <a:xfrm>
              <a:off x="8646769" y="4227901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3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B2BFC69D-CF2D-1D42-A925-2E4D5E0B2271}"/>
                </a:ext>
              </a:extLst>
            </p:cNvPr>
            <p:cNvSpPr txBox="1"/>
            <p:nvPr/>
          </p:nvSpPr>
          <p:spPr>
            <a:xfrm>
              <a:off x="3233316" y="4213210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3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12A82A79-1DE0-C049-BCDE-876FE9278D69}"/>
                </a:ext>
              </a:extLst>
            </p:cNvPr>
            <p:cNvSpPr txBox="1"/>
            <p:nvPr/>
          </p:nvSpPr>
          <p:spPr>
            <a:xfrm>
              <a:off x="6735540" y="4149693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2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36EA67A9-4458-FB44-A135-6DE3DB65DAE2}"/>
                </a:ext>
              </a:extLst>
            </p:cNvPr>
            <p:cNvSpPr txBox="1"/>
            <p:nvPr/>
          </p:nvSpPr>
          <p:spPr>
            <a:xfrm>
              <a:off x="7945869" y="4225408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A940312D-AA1A-8B44-92AC-622A0A1A7EC0}"/>
                </a:ext>
              </a:extLst>
            </p:cNvPr>
            <p:cNvSpPr txBox="1"/>
            <p:nvPr/>
          </p:nvSpPr>
          <p:spPr>
            <a:xfrm>
              <a:off x="5433840" y="4219621"/>
              <a:ext cx="4010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/2</a:t>
              </a:r>
            </a:p>
          </p:txBody>
        </p:sp>
      </p:grpSp>
      <p:sp>
        <p:nvSpPr>
          <p:cNvPr id="62" name="TextBox 61">
            <a:extLst>
              <a:ext uri="{FF2B5EF4-FFF2-40B4-BE49-F238E27FC236}">
                <a16:creationId xmlns:a16="http://schemas.microsoft.com/office/drawing/2014/main" id="{6A998DC9-8239-D745-9748-C776783A3883}"/>
              </a:ext>
            </a:extLst>
          </p:cNvPr>
          <p:cNvSpPr txBox="1"/>
          <p:nvPr/>
        </p:nvSpPr>
        <p:spPr>
          <a:xfrm>
            <a:off x="4524561" y="120652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8E1B2960-1CFF-9E43-8181-4FCE64EE51B9}"/>
              </a:ext>
            </a:extLst>
          </p:cNvPr>
          <p:cNvSpPr txBox="1"/>
          <p:nvPr/>
        </p:nvSpPr>
        <p:spPr>
          <a:xfrm>
            <a:off x="3582797" y="3758390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3610779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35</TotalTime>
  <Words>30</Words>
  <Application>Microsoft Macintosh PowerPoint</Application>
  <PresentationFormat>Widescreen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nnor Lewis</dc:creator>
  <cp:lastModifiedBy>Connor Lewis</cp:lastModifiedBy>
  <cp:revision>5</cp:revision>
  <dcterms:created xsi:type="dcterms:W3CDTF">2022-09-13T17:25:44Z</dcterms:created>
  <dcterms:modified xsi:type="dcterms:W3CDTF">2022-11-18T18:56:52Z</dcterms:modified>
</cp:coreProperties>
</file>